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5FA8D45-2502-4424-A3FC-2EE8A3F26F72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EFAD882-96CD-4297-A990-CFE641C865B4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FD550E8-BDBC-47F3-9525-2F1446B0BBE1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2AA9F97-9B8E-4D81-82A3-E5A652D0E12E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487656B-392B-4C19-993B-EFE579F66324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5C38740-5D05-420A-9E71-3910BFDDBCCA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B266B51-7B99-45E3-90F6-EFE257ADC843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4C93228-6764-444C-B59F-12465BD2E550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6589A8A-D745-4D60-B08D-5D4578A78B05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E23EEE-801D-4F6E-ABAF-D85D84908EED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5DD349D-0685-4E56-B07C-9A8F6DF5F0D8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51552B-4491-4A1A-A5BA-DE851B374606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34DCEF-8046-49C9-B244-488D5EE1A107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1" descr=""/>
          <p:cNvPicPr/>
          <p:nvPr/>
        </p:nvPicPr>
        <p:blipFill>
          <a:blip r:embed="rId1"/>
          <a:srcRect l="2698" t="20479" r="0" b="5934"/>
          <a:stretch/>
        </p:blipFill>
        <p:spPr>
          <a:xfrm>
            <a:off x="685800" y="838080"/>
            <a:ext cx="7924680" cy="2743200"/>
          </a:xfrm>
          <a:prstGeom prst="rect">
            <a:avLst/>
          </a:prstGeom>
          <a:ln w="0">
            <a:noFill/>
          </a:ln>
        </p:spPr>
      </p:pic>
      <p:sp>
        <p:nvSpPr>
          <p:cNvPr id="40" name="Line 2"/>
          <p:cNvSpPr/>
          <p:nvPr/>
        </p:nvSpPr>
        <p:spPr>
          <a:xfrm flipH="1">
            <a:off x="1142640" y="1600200"/>
            <a:ext cx="1066680" cy="2133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Line 3"/>
          <p:cNvSpPr/>
          <p:nvPr/>
        </p:nvSpPr>
        <p:spPr>
          <a:xfrm flipH="1">
            <a:off x="5409720" y="1905120"/>
            <a:ext cx="1295640" cy="1752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2409480" y="2819520"/>
            <a:ext cx="975600" cy="182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ha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6291360" y="2895480"/>
            <a:ext cx="975600" cy="182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hg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0"/>
          <p:cNvSpPr/>
          <p:nvPr/>
        </p:nvSpPr>
        <p:spPr>
          <a:xfrm>
            <a:off x="2971800" y="1752480"/>
            <a:ext cx="1295280" cy="1905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1"/>
          <p:cNvSpPr/>
          <p:nvPr/>
        </p:nvSpPr>
        <p:spPr>
          <a:xfrm>
            <a:off x="7467480" y="2057400"/>
            <a:ext cx="76320" cy="1600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37"/>
          <p:cNvGrpSpPr/>
          <p:nvPr/>
        </p:nvGrpSpPr>
        <p:grpSpPr>
          <a:xfrm>
            <a:off x="8026920" y="3657600"/>
            <a:ext cx="922680" cy="2590920"/>
            <a:chOff x="8026920" y="3657600"/>
            <a:chExt cx="922680" cy="2590920"/>
          </a:xfrm>
        </p:grpSpPr>
        <p:sp>
          <p:nvSpPr>
            <p:cNvPr id="47" name="Rectangle 6"/>
            <p:cNvSpPr/>
            <p:nvPr/>
          </p:nvSpPr>
          <p:spPr>
            <a:xfrm>
              <a:off x="8036640" y="3657600"/>
              <a:ext cx="91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pG island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7"/>
            <p:cNvSpPr/>
            <p:nvPr/>
          </p:nvSpPr>
          <p:spPr>
            <a:xfrm>
              <a:off x="8026920" y="3930120"/>
              <a:ext cx="835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crip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8"/>
            <p:cNvSpPr/>
            <p:nvPr/>
          </p:nvSpPr>
          <p:spPr>
            <a:xfrm>
              <a:off x="8294400" y="4920840"/>
              <a:ext cx="41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9"/>
            <p:cNvSpPr/>
            <p:nvPr/>
          </p:nvSpPr>
          <p:spPr>
            <a:xfrm>
              <a:off x="8224200" y="6063840"/>
              <a:ext cx="48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st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8287920" y="4387320"/>
              <a:ext cx="437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4"/>
            <p:cNvSpPr/>
            <p:nvPr/>
          </p:nvSpPr>
          <p:spPr>
            <a:xfrm>
              <a:off x="8077680" y="4946040"/>
              <a:ext cx="75960" cy="15228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1929" y="0"/>
                    <a:pt x="21600" y="806"/>
                    <a:pt x="21600" y="1800"/>
                  </a:cubicBezTo>
                  <a:lnTo>
                    <a:pt x="21600" y="19800"/>
                  </a:lnTo>
                  <a:cubicBezTo>
                    <a:pt x="21600" y="20794"/>
                    <a:pt x="11929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5"/>
            <p:cNvSpPr/>
            <p:nvPr/>
          </p:nvSpPr>
          <p:spPr>
            <a:xfrm>
              <a:off x="8077680" y="5562720"/>
              <a:ext cx="75960" cy="15228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1929" y="0"/>
                    <a:pt x="21600" y="806"/>
                    <a:pt x="21600" y="1800"/>
                  </a:cubicBezTo>
                  <a:lnTo>
                    <a:pt x="21600" y="19800"/>
                  </a:lnTo>
                  <a:cubicBezTo>
                    <a:pt x="21600" y="20794"/>
                    <a:pt x="11929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6"/>
            <p:cNvSpPr/>
            <p:nvPr/>
          </p:nvSpPr>
          <p:spPr>
            <a:xfrm>
              <a:off x="8077680" y="4387320"/>
              <a:ext cx="75960" cy="15228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1929" y="0"/>
                    <a:pt x="21600" y="806"/>
                    <a:pt x="21600" y="1800"/>
                  </a:cubicBezTo>
                  <a:lnTo>
                    <a:pt x="21600" y="19800"/>
                  </a:lnTo>
                  <a:cubicBezTo>
                    <a:pt x="21600" y="20794"/>
                    <a:pt x="11929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7"/>
            <p:cNvSpPr/>
            <p:nvPr/>
          </p:nvSpPr>
          <p:spPr>
            <a:xfrm>
              <a:off x="8094600" y="6096240"/>
              <a:ext cx="75960" cy="15228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1929" y="0"/>
                    <a:pt x="21600" y="806"/>
                    <a:pt x="21600" y="1800"/>
                  </a:cubicBezTo>
                  <a:lnTo>
                    <a:pt x="21600" y="19800"/>
                  </a:lnTo>
                  <a:cubicBezTo>
                    <a:pt x="21600" y="20794"/>
                    <a:pt x="11929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6"/>
            <p:cNvSpPr/>
            <p:nvPr/>
          </p:nvSpPr>
          <p:spPr>
            <a:xfrm>
              <a:off x="8251560" y="5511960"/>
              <a:ext cx="454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7" name="Picture 32" descr=""/>
          <p:cNvPicPr/>
          <p:nvPr/>
        </p:nvPicPr>
        <p:blipFill>
          <a:blip r:embed="rId2"/>
          <a:srcRect l="16923" t="7693" r="0" b="38463"/>
          <a:stretch/>
        </p:blipFill>
        <p:spPr>
          <a:xfrm>
            <a:off x="838080" y="3657600"/>
            <a:ext cx="3657600" cy="27432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3" descr=""/>
          <p:cNvPicPr/>
          <p:nvPr/>
        </p:nvPicPr>
        <p:blipFill>
          <a:blip r:embed="rId3"/>
          <a:srcRect l="21604" t="7693" r="0" b="38462"/>
          <a:stretch/>
        </p:blipFill>
        <p:spPr>
          <a:xfrm>
            <a:off x="4876920" y="3657600"/>
            <a:ext cx="3124080" cy="274320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34"/>
          <p:cNvSpPr/>
          <p:nvPr/>
        </p:nvSpPr>
        <p:spPr>
          <a:xfrm>
            <a:off x="810000" y="228600"/>
            <a:ext cx="75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. DNA methylation and alternative promoters for Pcdha ge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36"/>
          <p:cNvGrpSpPr/>
          <p:nvPr/>
        </p:nvGrpSpPr>
        <p:grpSpPr>
          <a:xfrm>
            <a:off x="921600" y="6477120"/>
            <a:ext cx="8061480" cy="196920"/>
            <a:chOff x="921600" y="6477120"/>
            <a:chExt cx="8061480" cy="196920"/>
          </a:xfrm>
        </p:grpSpPr>
        <p:sp>
          <p:nvSpPr>
            <p:cNvPr id="61" name="Rectangle 30"/>
            <p:cNvSpPr/>
            <p:nvPr/>
          </p:nvSpPr>
          <p:spPr>
            <a:xfrm>
              <a:off x="921600" y="6491160"/>
              <a:ext cx="345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                  2                3         4   5                 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1"/>
            <p:cNvSpPr/>
            <p:nvPr/>
          </p:nvSpPr>
          <p:spPr>
            <a:xfrm>
              <a:off x="5245200" y="6491160"/>
              <a:ext cx="225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  8       910    11 12             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5"/>
            <p:cNvSpPr/>
            <p:nvPr/>
          </p:nvSpPr>
          <p:spPr>
            <a:xfrm>
              <a:off x="7600680" y="6477120"/>
              <a:ext cx="138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hylation Peak#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49:24Z</dcterms:modified>
  <cp:revision>76</cp:revision>
  <dc:subject/>
  <dc:title>PowerPoint Presentation</dc:title>
</cp:coreProperties>
</file>